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319588" cy="5580063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63BBB4-1B24-4514-906E-719A8F654C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16000" y="223920"/>
            <a:ext cx="3889440" cy="93024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16000" y="1301400"/>
            <a:ext cx="388944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16000" y="3225600"/>
            <a:ext cx="388944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ECE14B-B699-4F71-A2F5-86170D666A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16000" y="223920"/>
            <a:ext cx="3889440" cy="93024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16000" y="1301400"/>
            <a:ext cx="189792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209320" y="1301400"/>
            <a:ext cx="189792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16000" y="3225600"/>
            <a:ext cx="189792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209320" y="3225600"/>
            <a:ext cx="189792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70DCC3-486D-4195-9109-32B9FDE2EC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16000" y="223920"/>
            <a:ext cx="3889440" cy="93024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16000" y="1301400"/>
            <a:ext cx="125208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531080" y="1301400"/>
            <a:ext cx="125208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846160" y="1301400"/>
            <a:ext cx="125208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16000" y="3225600"/>
            <a:ext cx="125208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531080" y="3225600"/>
            <a:ext cx="125208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846160" y="3225600"/>
            <a:ext cx="125208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D8C436-3282-4546-96D6-E5E6C93B5E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16000" y="223920"/>
            <a:ext cx="3889440" cy="93024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16000" y="1301400"/>
            <a:ext cx="3889440" cy="3683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99"/>
              </a:spcBef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826690-94BA-4806-BD73-BC9D698DF7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16000" y="223920"/>
            <a:ext cx="3889440" cy="93024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16000" y="1301400"/>
            <a:ext cx="3889440" cy="3683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60E18-DA32-49D0-A5EE-AD8E60350C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16000" y="223920"/>
            <a:ext cx="3889440" cy="93024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16000" y="1301400"/>
            <a:ext cx="1897920" cy="3683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209320" y="1301400"/>
            <a:ext cx="1897920" cy="3683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194CF-178C-4264-A66A-E6C1BE306C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16000" y="223920"/>
            <a:ext cx="3889440" cy="93024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6E19CF-0A75-4DFB-AF8E-52DB0C5C07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16000" y="223920"/>
            <a:ext cx="3889440" cy="431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99"/>
              </a:spcBef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05D779-DC07-4ED2-B70E-D2544D0EC3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16000" y="223920"/>
            <a:ext cx="3889440" cy="93024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16000" y="1301400"/>
            <a:ext cx="189792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209320" y="1301400"/>
            <a:ext cx="1897920" cy="3683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16000" y="3225600"/>
            <a:ext cx="189792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A3B587-000E-4482-B812-B6A8FD88A7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16000" y="223920"/>
            <a:ext cx="3889440" cy="93024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16000" y="1301400"/>
            <a:ext cx="1897920" cy="3683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209320" y="1301400"/>
            <a:ext cx="189792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209320" y="3225600"/>
            <a:ext cx="189792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4CC434-7083-4BDC-B888-6A55381302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16000" y="223920"/>
            <a:ext cx="3889440" cy="93024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16000" y="1301400"/>
            <a:ext cx="189792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209320" y="1301400"/>
            <a:ext cx="189792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16000" y="3225600"/>
            <a:ext cx="3889440" cy="17568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574358-F4B6-46B0-9FD8-90484D224F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16000" y="223920"/>
            <a:ext cx="3889440" cy="93024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16000" y="1301400"/>
            <a:ext cx="3889440" cy="3683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marL="212760" indent="-212760"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460440" indent="-17784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706320" indent="-141120"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3" marL="990720" indent="-14148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1273320" indent="-14148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1273320" indent="-14148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1273320" indent="-14148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16000" y="5081400"/>
            <a:ext cx="1008000" cy="387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Autofit/>
          </a:bodyPr>
          <a:lstStyle>
            <a:lvl1pPr indent="0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476000" y="5081400"/>
            <a:ext cx="1368360" cy="387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Autofit/>
          </a:bodyPr>
          <a:lstStyle>
            <a:lvl1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096720" y="5081400"/>
            <a:ext cx="1008360" cy="387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Autofit/>
          </a:bodyPr>
          <a:lstStyle>
            <a:lvl1pPr indent="0" algn="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  <a:defRPr b="0" lang="en-US" sz="9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fld id="{849BA85A-18FF-45BB-83EE-C65F40267F2E}" type="slidenum">
              <a:rPr b="0" lang="en-US" sz="9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893880" y="426960"/>
            <a:ext cx="3219480" cy="221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893880" y="426960"/>
            <a:ext cx="3219480" cy="221940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932040" y="922320"/>
            <a:ext cx="66600" cy="1143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074600" y="922320"/>
            <a:ext cx="57240" cy="1628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208160" y="922320"/>
            <a:ext cx="66600" cy="13622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351080" y="922320"/>
            <a:ext cx="66600" cy="1371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494000" y="922320"/>
            <a:ext cx="56880" cy="15908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627200" y="922320"/>
            <a:ext cx="66600" cy="9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770120" y="588960"/>
            <a:ext cx="66600" cy="33336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913040" y="865080"/>
            <a:ext cx="66600" cy="5724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055960" y="922320"/>
            <a:ext cx="56880" cy="17136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189160" y="922320"/>
            <a:ext cx="66600" cy="8568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332080" y="922320"/>
            <a:ext cx="66600" cy="10476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475000" y="750960"/>
            <a:ext cx="57240" cy="17136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608200" y="922320"/>
            <a:ext cx="66600" cy="13320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751120" y="770040"/>
            <a:ext cx="66600" cy="15228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894040" y="922320"/>
            <a:ext cx="57240" cy="28584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027240" y="922320"/>
            <a:ext cx="66960" cy="972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170160" y="922320"/>
            <a:ext cx="66600" cy="28584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313080" y="722160"/>
            <a:ext cx="66600" cy="20016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456000" y="560520"/>
            <a:ext cx="57240" cy="36180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589200" y="922320"/>
            <a:ext cx="66960" cy="9540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732120" y="903240"/>
            <a:ext cx="66600" cy="1908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875040" y="808200"/>
            <a:ext cx="57240" cy="11412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008600" y="922320"/>
            <a:ext cx="66600" cy="18108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893880" y="2398680"/>
            <a:ext cx="284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893880" y="2151000"/>
            <a:ext cx="284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893880" y="1903320"/>
            <a:ext cx="284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893880" y="1655640"/>
            <a:ext cx="284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893880" y="1417680"/>
            <a:ext cx="284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893880" y="922320"/>
            <a:ext cx="284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893880" y="674640"/>
            <a:ext cx="284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893880" y="426960"/>
            <a:ext cx="284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893880" y="922320"/>
            <a:ext cx="32194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flipV="1">
            <a:off x="89388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V="1">
            <a:off x="103680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flipV="1">
            <a:off x="117000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V="1">
            <a:off x="131292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145584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V="1">
            <a:off x="1589040" y="89352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173196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V="1">
            <a:off x="187488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201780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V="1">
            <a:off x="2151000" y="89352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V="1">
            <a:off x="229392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flipV="1">
            <a:off x="243684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flipV="1">
            <a:off x="2570040" y="89352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V="1">
            <a:off x="2712960" y="89352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V="1">
            <a:off x="2855880" y="89352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flipV="1">
            <a:off x="298944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3132000" y="89352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flipV="1">
            <a:off x="3274920" y="89352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flipV="1">
            <a:off x="3417840" y="89352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flipV="1">
            <a:off x="355140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flipV="1">
            <a:off x="3693960" y="89352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 flipV="1">
            <a:off x="3836880" y="893520"/>
            <a:ext cx="180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flipV="1">
            <a:off x="397044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flipV="1">
            <a:off x="4113360" y="893520"/>
            <a:ext cx="1440" cy="28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83200" y="257004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-3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583200" y="232236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-3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83200" y="207504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-2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583200" y="182736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-2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583200" y="157968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-1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583200" y="134136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-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583200" y="109368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-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628920" y="846000"/>
            <a:ext cx="17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628920" y="598320"/>
            <a:ext cx="17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628920" y="351000"/>
            <a:ext cx="17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871560" y="3138480"/>
            <a:ext cx="3260880" cy="221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871560" y="3138480"/>
            <a:ext cx="3260880" cy="2219400"/>
          </a:xfrm>
          <a:prstGeom prst="rect">
            <a:avLst/>
          </a:prstGeom>
          <a:noFill/>
          <a:ln w="792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914400" y="4248000"/>
            <a:ext cx="52560" cy="42552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1054080" y="4248000"/>
            <a:ext cx="60480" cy="3906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201680" y="4248000"/>
            <a:ext cx="50760" cy="84168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339920" y="4248000"/>
            <a:ext cx="52200" cy="73692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477800" y="4248000"/>
            <a:ext cx="61920" cy="63360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625760" y="4248000"/>
            <a:ext cx="52200" cy="113040"/>
          </a:xfrm>
          <a:prstGeom prst="rect">
            <a:avLst/>
          </a:prstGeom>
          <a:solidFill>
            <a:srgbClr val="000000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765440" y="3909960"/>
            <a:ext cx="50760" cy="33804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903320" y="4195800"/>
            <a:ext cx="60480" cy="5220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050920" y="3424320"/>
            <a:ext cx="52560" cy="82368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2189160" y="3832200"/>
            <a:ext cx="52560" cy="41580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328840" y="4205160"/>
            <a:ext cx="60480" cy="4284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475000" y="4248000"/>
            <a:ext cx="52200" cy="6048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2614680" y="4100400"/>
            <a:ext cx="60120" cy="14760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2762280" y="4248000"/>
            <a:ext cx="50760" cy="4284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2900520" y="4248000"/>
            <a:ext cx="52200" cy="20808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038400" y="4248000"/>
            <a:ext cx="61920" cy="39852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3186000" y="4248000"/>
            <a:ext cx="52560" cy="13032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325680" y="4248000"/>
            <a:ext cx="50760" cy="3492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463920" y="4248000"/>
            <a:ext cx="60480" cy="13032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3611520" y="4160880"/>
            <a:ext cx="52560" cy="8712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320" bIns="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3749760" y="4248000"/>
            <a:ext cx="52200" cy="46836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3889440" y="4248000"/>
            <a:ext cx="60120" cy="41616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035600" y="4248000"/>
            <a:ext cx="52200" cy="25560"/>
          </a:xfrm>
          <a:prstGeom prst="rect">
            <a:avLst/>
          </a:prstGeom>
          <a:solidFill>
            <a:srgbClr val="dddddd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871560" y="5357880"/>
            <a:ext cx="270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871560" y="5079960"/>
            <a:ext cx="270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871560" y="4802040"/>
            <a:ext cx="270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871560" y="4248000"/>
            <a:ext cx="270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871560" y="3970440"/>
            <a:ext cx="270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871560" y="3693960"/>
            <a:ext cx="270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871560" y="3416400"/>
            <a:ext cx="270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871560" y="3138480"/>
            <a:ext cx="270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871560" y="4248000"/>
            <a:ext cx="32608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flipV="1">
            <a:off x="87156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 flipV="1">
            <a:off x="101124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flipV="1">
            <a:off x="115740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flipV="1">
            <a:off x="129708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 flipV="1">
            <a:off x="1434960" y="4222800"/>
            <a:ext cx="180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flipV="1">
            <a:off x="1582560" y="4222800"/>
            <a:ext cx="180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 flipV="1">
            <a:off x="1720800" y="4222800"/>
            <a:ext cx="180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flipV="1">
            <a:off x="1860480" y="4222800"/>
            <a:ext cx="180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flipV="1">
            <a:off x="2008080" y="4222800"/>
            <a:ext cx="180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flipV="1">
            <a:off x="214632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flipV="1">
            <a:off x="228456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243216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flipV="1">
            <a:off x="257184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flipV="1">
            <a:off x="2717640" y="4222800"/>
            <a:ext cx="180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flipV="1">
            <a:off x="285768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 flipV="1">
            <a:off x="2995560" y="4222800"/>
            <a:ext cx="180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 flipV="1">
            <a:off x="3143160" y="4222800"/>
            <a:ext cx="180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 flipV="1">
            <a:off x="328140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flipV="1">
            <a:off x="342108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 flipV="1">
            <a:off x="356868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 flipV="1">
            <a:off x="370692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 flipV="1">
            <a:off x="3844800" y="4222800"/>
            <a:ext cx="180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 flipV="1">
            <a:off x="3992400" y="4222800"/>
            <a:ext cx="180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 flipV="1">
            <a:off x="4132440" y="4222800"/>
            <a:ext cx="1440" cy="25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601920" y="531504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-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601920" y="503712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-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601920" y="475920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-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601920" y="448164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-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643320" y="4205160"/>
            <a:ext cx="17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643320" y="3927600"/>
            <a:ext cx="17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643320" y="3649680"/>
            <a:ext cx="17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643320" y="3373560"/>
            <a:ext cx="17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643320" y="3095640"/>
            <a:ext cx="177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ＭＳ Ｐゴシック"/>
                <a:ea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 rot="16200000">
            <a:off x="-902160" y="1363320"/>
            <a:ext cx="2593080" cy="483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log</a:t>
            </a:r>
            <a:r>
              <a:rPr b="0" lang="ja-JP" sz="12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 (CCND1/CDKN2A) expres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(microarray dat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rot="16200000">
            <a:off x="-457920" y="3989160"/>
            <a:ext cx="1704600" cy="483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log</a:t>
            </a:r>
            <a:r>
              <a:rPr b="0" lang="ja-JP" sz="12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10</a:t>
            </a: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 (RB1) expres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  <a:ea typeface="Arial"/>
              </a:rPr>
              <a:t>(microarray dat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567000" y="936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584280" y="279864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3422520" y="2309760"/>
            <a:ext cx="7164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840" bIns="24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3422520" y="2459160"/>
            <a:ext cx="71640" cy="7128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480" bIns="24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3465360" y="2217600"/>
            <a:ext cx="587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um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orm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3441600" y="3301920"/>
            <a:ext cx="71640" cy="71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840" bIns="24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3441600" y="3451320"/>
            <a:ext cx="71640" cy="71280"/>
          </a:xfrm>
          <a:prstGeom prst="rect">
            <a:avLst/>
          </a:pr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480" bIns="244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3484440" y="3209760"/>
            <a:ext cx="587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umo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orm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2136960" y="10944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CL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5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9T01:37:15Z</dcterms:created>
  <dc:creator>Merck</dc:creator>
  <dc:description/>
  <dc:language>en-US</dc:language>
  <cp:lastModifiedBy>X40312</cp:lastModifiedBy>
  <dcterms:modified xsi:type="dcterms:W3CDTF">2011-02-23T19:00:32Z</dcterms:modified>
  <cp:revision>81</cp:revision>
  <dc:subject/>
  <dc:title>スライド 1</dc:title>
</cp:coreProperties>
</file>